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529D1"/>
    <a:srgbClr val="172391"/>
    <a:srgbClr val="0060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2138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86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814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4663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663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3588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291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533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51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992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516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4D82EF-E77E-42F9-8402-C45245A16599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E1B90-2CFC-406D-9723-FCEADBE81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14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6728BF74-57F9-99D9-5995-EC56600633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58897" y="337030"/>
            <a:ext cx="3780633" cy="276840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0B46BB24-C9D6-1C13-0362-8F05782975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8483" y="348059"/>
            <a:ext cx="3694730" cy="2705503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B026EA1F-B7FD-72FB-4DD8-70F57F9D4D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1845" y="3163377"/>
            <a:ext cx="3802241" cy="2784228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8C67E650-01D3-5839-BB8B-D9CF6B7698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78899" y="3151796"/>
            <a:ext cx="3780632" cy="2768406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96F0E3D-CE8B-8F52-97FE-BCC8C9F5550C}"/>
              </a:ext>
            </a:extLst>
          </p:cNvPr>
          <p:cNvSpPr txBox="1"/>
          <p:nvPr/>
        </p:nvSpPr>
        <p:spPr>
          <a:xfrm>
            <a:off x="7569191" y="20996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02E0FE1-6B28-FE11-C66C-793AFE874484}"/>
              </a:ext>
            </a:extLst>
          </p:cNvPr>
          <p:cNvSpPr txBox="1"/>
          <p:nvPr/>
        </p:nvSpPr>
        <p:spPr>
          <a:xfrm>
            <a:off x="4926105" y="17684"/>
            <a:ext cx="1919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58A1C47-3AF2-FD14-1D5A-0FA868B94BB9}"/>
              </a:ext>
            </a:extLst>
          </p:cNvPr>
          <p:cNvSpPr txBox="1"/>
          <p:nvPr/>
        </p:nvSpPr>
        <p:spPr>
          <a:xfrm>
            <a:off x="2077240" y="6151378"/>
            <a:ext cx="77736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log plot for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rtiles of TSAT (A) and serum ferritin (C)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 of proportional hazard assumption for quartiles of TSAT (B) and serum ferritin (D); red lines indicate regression lines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AT, transferrin saturation.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9639734-A968-D06D-2857-D69F57C31316}"/>
              </a:ext>
            </a:extLst>
          </p:cNvPr>
          <p:cNvSpPr txBox="1"/>
          <p:nvPr/>
        </p:nvSpPr>
        <p:spPr>
          <a:xfrm>
            <a:off x="3220489" y="2895921"/>
            <a:ext cx="1386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(analysis time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C79E454-EC04-BFC9-0B7F-93AE17CB2D46}"/>
              </a:ext>
            </a:extLst>
          </p:cNvPr>
          <p:cNvSpPr txBox="1"/>
          <p:nvPr/>
        </p:nvSpPr>
        <p:spPr>
          <a:xfrm>
            <a:off x="8540945" y="2895875"/>
            <a:ext cx="1128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tim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0A92465-20A1-1954-282E-61AED1922065}"/>
              </a:ext>
            </a:extLst>
          </p:cNvPr>
          <p:cNvSpPr txBox="1"/>
          <p:nvPr/>
        </p:nvSpPr>
        <p:spPr>
          <a:xfrm rot="16200000">
            <a:off x="5487192" y="4257315"/>
            <a:ext cx="29626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d Schoenfeld-quartiles of serum ferriti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441197F-6380-F78A-112A-A85598EFF590}"/>
              </a:ext>
            </a:extLst>
          </p:cNvPr>
          <p:cNvSpPr txBox="1"/>
          <p:nvPr/>
        </p:nvSpPr>
        <p:spPr>
          <a:xfrm>
            <a:off x="7569191" y="307961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2F4F138-EC57-17EF-BA86-65CD0EE0C6C6}"/>
              </a:ext>
            </a:extLst>
          </p:cNvPr>
          <p:cNvSpPr txBox="1"/>
          <p:nvPr/>
        </p:nvSpPr>
        <p:spPr>
          <a:xfrm>
            <a:off x="8540945" y="5790892"/>
            <a:ext cx="1128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tim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C99689E-4FB0-B839-A6C2-734E7C7AC6C7}"/>
              </a:ext>
            </a:extLst>
          </p:cNvPr>
          <p:cNvSpPr txBox="1"/>
          <p:nvPr/>
        </p:nvSpPr>
        <p:spPr>
          <a:xfrm rot="16200000">
            <a:off x="5727129" y="1514504"/>
            <a:ext cx="2482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d Schoenfeld-quartiles of TSA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302646C-3B3D-E0EA-6E27-7FA13F3F082B}"/>
              </a:ext>
            </a:extLst>
          </p:cNvPr>
          <p:cNvSpPr txBox="1"/>
          <p:nvPr/>
        </p:nvSpPr>
        <p:spPr>
          <a:xfrm>
            <a:off x="3220489" y="5847641"/>
            <a:ext cx="13869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(analysis time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A80A2C9-DEFD-EDC4-7DFD-DB96DC32B42E}"/>
              </a:ext>
            </a:extLst>
          </p:cNvPr>
          <p:cNvSpPr txBox="1"/>
          <p:nvPr/>
        </p:nvSpPr>
        <p:spPr>
          <a:xfrm rot="16200000">
            <a:off x="291741" y="1438930"/>
            <a:ext cx="26339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n[-ln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probability)]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31E544A-D5FF-B707-0699-15F4F56B7672}"/>
              </a:ext>
            </a:extLst>
          </p:cNvPr>
          <p:cNvSpPr txBox="1"/>
          <p:nvPr/>
        </p:nvSpPr>
        <p:spPr>
          <a:xfrm rot="16200000">
            <a:off x="291741" y="4223940"/>
            <a:ext cx="26339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n[-ln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probability)]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2F6F331-3C68-5134-83A1-5D6C78DE41D4}"/>
              </a:ext>
            </a:extLst>
          </p:cNvPr>
          <p:cNvSpPr txBox="1"/>
          <p:nvPr/>
        </p:nvSpPr>
        <p:spPr>
          <a:xfrm>
            <a:off x="2184214" y="2099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3BADE5C-278C-CAC8-AD2A-5C02F871509F}"/>
              </a:ext>
            </a:extLst>
          </p:cNvPr>
          <p:cNvSpPr txBox="1"/>
          <p:nvPr/>
        </p:nvSpPr>
        <p:spPr>
          <a:xfrm>
            <a:off x="2204497" y="307961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DEBC4BF2-8DDD-3F17-F14F-EA915835E2A4}"/>
              </a:ext>
            </a:extLst>
          </p:cNvPr>
          <p:cNvGrpSpPr/>
          <p:nvPr/>
        </p:nvGrpSpPr>
        <p:grpSpPr>
          <a:xfrm>
            <a:off x="4102084" y="396218"/>
            <a:ext cx="1247388" cy="858972"/>
            <a:chOff x="2129969" y="725265"/>
            <a:chExt cx="1247388" cy="858972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E6F1B38A-4566-6766-8908-8EBD9ADD659F}"/>
                </a:ext>
              </a:extLst>
            </p:cNvPr>
            <p:cNvSpPr txBox="1"/>
            <p:nvPr/>
          </p:nvSpPr>
          <p:spPr>
            <a:xfrm>
              <a:off x="2539124" y="1126580"/>
              <a:ext cx="8338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3 of TSAT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128A18D5-8BD0-BA35-C8A3-69B4FC08BF89}"/>
                </a:ext>
              </a:extLst>
            </p:cNvPr>
            <p:cNvSpPr txBox="1"/>
            <p:nvPr/>
          </p:nvSpPr>
          <p:spPr>
            <a:xfrm>
              <a:off x="2530415" y="725265"/>
              <a:ext cx="8338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1 of TSAT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6F1601BB-6A83-4264-EB4C-F821539D48B3}"/>
                </a:ext>
              </a:extLst>
            </p:cNvPr>
            <p:cNvSpPr txBox="1"/>
            <p:nvPr/>
          </p:nvSpPr>
          <p:spPr>
            <a:xfrm>
              <a:off x="2530415" y="920628"/>
              <a:ext cx="8338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2 of TSAT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FC149471-CF80-E1C2-697B-393FEC2B676E}"/>
                </a:ext>
              </a:extLst>
            </p:cNvPr>
            <p:cNvGrpSpPr/>
            <p:nvPr/>
          </p:nvGrpSpPr>
          <p:grpSpPr>
            <a:xfrm>
              <a:off x="2138678" y="1141968"/>
              <a:ext cx="400050" cy="215444"/>
              <a:chOff x="3486150" y="5638800"/>
              <a:chExt cx="400050" cy="215444"/>
            </a:xfrm>
          </p:grpSpPr>
          <p:cxnSp>
            <p:nvCxnSpPr>
              <p:cNvPr id="8" name="直線コネクタ 7">
                <a:extLst>
                  <a:ext uri="{FF2B5EF4-FFF2-40B4-BE49-F238E27FC236}">
                    <a16:creationId xmlns:a16="http://schemas.microsoft.com/office/drawing/2014/main" id="{7F041DC4-36D6-FCEE-1946-9D6AF58C2F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86150" y="5736997"/>
                <a:ext cx="40005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F9ABE82B-09D5-440F-FE20-7BFBD2BE443E}"/>
                  </a:ext>
                </a:extLst>
              </p:cNvPr>
              <p:cNvSpPr txBox="1"/>
              <p:nvPr/>
            </p:nvSpPr>
            <p:spPr>
              <a:xfrm>
                <a:off x="3544654" y="5638800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800" dirty="0"/>
                  <a:t>●</a:t>
                </a:r>
                <a:endParaRPr kumimoji="1" lang="ja-JP" altLang="en-US" sz="800" dirty="0"/>
              </a:p>
            </p:txBody>
          </p:sp>
        </p:grp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71CF9B59-1BFF-6DC4-8EFE-468B534623C8}"/>
                </a:ext>
              </a:extLst>
            </p:cNvPr>
            <p:cNvCxnSpPr>
              <a:cxnSpLocks/>
            </p:cNvCxnSpPr>
            <p:nvPr/>
          </p:nvCxnSpPr>
          <p:spPr>
            <a:xfrm>
              <a:off x="2129969" y="838850"/>
              <a:ext cx="400050" cy="0"/>
            </a:xfrm>
            <a:prstGeom prst="line">
              <a:avLst/>
            </a:prstGeom>
            <a:ln>
              <a:solidFill>
                <a:srgbClr val="2529D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D89F3F83-620B-343B-5042-A4A9FDDEAE52}"/>
                </a:ext>
              </a:extLst>
            </p:cNvPr>
            <p:cNvSpPr txBox="1"/>
            <p:nvPr/>
          </p:nvSpPr>
          <p:spPr>
            <a:xfrm>
              <a:off x="2203599" y="74065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800" dirty="0">
                  <a:solidFill>
                    <a:srgbClr val="2529D1"/>
                  </a:solidFill>
                </a:rPr>
                <a:t>●</a:t>
              </a:r>
              <a:endParaRPr kumimoji="1" lang="ja-JP" altLang="en-US" sz="800" dirty="0">
                <a:solidFill>
                  <a:srgbClr val="2529D1"/>
                </a:solidFill>
              </a:endParaRPr>
            </a:p>
          </p:txBody>
        </p:sp>
        <p:grpSp>
          <p:nvGrpSpPr>
            <p:cNvPr id="37" name="グループ化 36">
              <a:extLst>
                <a:ext uri="{FF2B5EF4-FFF2-40B4-BE49-F238E27FC236}">
                  <a16:creationId xmlns:a16="http://schemas.microsoft.com/office/drawing/2014/main" id="{3A06D68D-AA78-9A88-6AB3-7C7267EAFFA0}"/>
                </a:ext>
              </a:extLst>
            </p:cNvPr>
            <p:cNvGrpSpPr/>
            <p:nvPr/>
          </p:nvGrpSpPr>
          <p:grpSpPr>
            <a:xfrm>
              <a:off x="2129969" y="936016"/>
              <a:ext cx="400050" cy="215444"/>
              <a:chOff x="3629025" y="990600"/>
              <a:chExt cx="400050" cy="215444"/>
            </a:xfrm>
          </p:grpSpPr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id="{8C358059-7037-A5E4-E1AF-DEE88ADD9B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29025" y="1088797"/>
                <a:ext cx="40005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430BB4E2-4DB1-DBB5-7847-89A1C1B97917}"/>
                  </a:ext>
                </a:extLst>
              </p:cNvPr>
              <p:cNvSpPr txBox="1"/>
              <p:nvPr/>
            </p:nvSpPr>
            <p:spPr>
              <a:xfrm>
                <a:off x="3706579" y="990600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800" dirty="0">
                    <a:solidFill>
                      <a:srgbClr val="FF0000"/>
                    </a:solidFill>
                  </a:rPr>
                  <a:t>●</a:t>
                </a:r>
                <a:endParaRPr kumimoji="1" lang="ja-JP" altLang="en-US" sz="8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F9A110E2-F535-3F73-9B8B-64E3BE2215E6}"/>
                </a:ext>
              </a:extLst>
            </p:cNvPr>
            <p:cNvSpPr txBox="1"/>
            <p:nvPr/>
          </p:nvSpPr>
          <p:spPr>
            <a:xfrm>
              <a:off x="2543474" y="1330551"/>
              <a:ext cx="8338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4 of TSAT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855829C6-293B-6EEF-E3F9-CE21C6EFFA5F}"/>
                </a:ext>
              </a:extLst>
            </p:cNvPr>
            <p:cNvGrpSpPr/>
            <p:nvPr/>
          </p:nvGrpSpPr>
          <p:grpSpPr>
            <a:xfrm>
              <a:off x="2143028" y="1368793"/>
              <a:ext cx="400050" cy="215444"/>
              <a:chOff x="2160446" y="672104"/>
              <a:chExt cx="400050" cy="215444"/>
            </a:xfrm>
          </p:grpSpPr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E0E81F54-22BE-AE47-35E6-E6D8E9C269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60446" y="770301"/>
                <a:ext cx="400050" cy="0"/>
              </a:xfrm>
              <a:prstGeom prst="line">
                <a:avLst/>
              </a:prstGeom>
              <a:ln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421FA1B7-2C47-EF1C-2954-376374CB9AB9}"/>
                  </a:ext>
                </a:extLst>
              </p:cNvPr>
              <p:cNvSpPr txBox="1"/>
              <p:nvPr/>
            </p:nvSpPr>
            <p:spPr>
              <a:xfrm>
                <a:off x="2238000" y="672104"/>
                <a:ext cx="28725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800" dirty="0">
                    <a:solidFill>
                      <a:srgbClr val="00B050"/>
                    </a:solidFill>
                  </a:rPr>
                  <a:t>●</a:t>
                </a:r>
                <a:endParaRPr kumimoji="1" lang="ja-JP" altLang="en-US" sz="800" dirty="0">
                  <a:solidFill>
                    <a:srgbClr val="00B050"/>
                  </a:solidFill>
                </a:endParaRPr>
              </a:p>
            </p:txBody>
          </p:sp>
        </p:grp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8343994A-B4F7-48F0-74C4-4C049C5AF5A9}"/>
              </a:ext>
            </a:extLst>
          </p:cNvPr>
          <p:cNvGrpSpPr/>
          <p:nvPr/>
        </p:nvGrpSpPr>
        <p:grpSpPr>
          <a:xfrm>
            <a:off x="4034143" y="3368987"/>
            <a:ext cx="1630505" cy="858972"/>
            <a:chOff x="1977555" y="3681829"/>
            <a:chExt cx="1630505" cy="858972"/>
          </a:xfrm>
        </p:grpSpPr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BFF49DE5-E5D4-834B-3AFB-171B34AD25CE}"/>
                </a:ext>
              </a:extLst>
            </p:cNvPr>
            <p:cNvSpPr txBox="1"/>
            <p:nvPr/>
          </p:nvSpPr>
          <p:spPr>
            <a:xfrm>
              <a:off x="2386710" y="4083144"/>
              <a:ext cx="1217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3 of serum ferritin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BC834F36-1651-8D4F-7DDE-874A18B00DA3}"/>
                </a:ext>
              </a:extLst>
            </p:cNvPr>
            <p:cNvSpPr txBox="1"/>
            <p:nvPr/>
          </p:nvSpPr>
          <p:spPr>
            <a:xfrm>
              <a:off x="2378001" y="3681829"/>
              <a:ext cx="1217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1 of serum ferritin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C0580B59-DE5D-275B-6846-E9583D49FF86}"/>
                </a:ext>
              </a:extLst>
            </p:cNvPr>
            <p:cNvSpPr txBox="1"/>
            <p:nvPr/>
          </p:nvSpPr>
          <p:spPr>
            <a:xfrm>
              <a:off x="2378001" y="3877192"/>
              <a:ext cx="1217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2 of serum ferritin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89092E30-5FB5-D17B-8683-12558E368C69}"/>
                </a:ext>
              </a:extLst>
            </p:cNvPr>
            <p:cNvGrpSpPr/>
            <p:nvPr/>
          </p:nvGrpSpPr>
          <p:grpSpPr>
            <a:xfrm>
              <a:off x="1986264" y="4098532"/>
              <a:ext cx="400050" cy="215444"/>
              <a:chOff x="3486150" y="5638800"/>
              <a:chExt cx="400050" cy="215444"/>
            </a:xfrm>
          </p:grpSpPr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CFC73370-347E-6427-F822-483B6B538A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86150" y="5736997"/>
                <a:ext cx="40005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5166156C-D844-EB9D-25E6-ADBB61DF9726}"/>
                  </a:ext>
                </a:extLst>
              </p:cNvPr>
              <p:cNvSpPr txBox="1"/>
              <p:nvPr/>
            </p:nvSpPr>
            <p:spPr>
              <a:xfrm>
                <a:off x="3553363" y="5638800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800" dirty="0"/>
                  <a:t>●</a:t>
                </a:r>
                <a:endParaRPr kumimoji="1" lang="ja-JP" altLang="en-US" sz="800" dirty="0"/>
              </a:p>
            </p:txBody>
          </p:sp>
        </p:grpSp>
        <p:grpSp>
          <p:nvGrpSpPr>
            <p:cNvPr id="54" name="グループ化 53">
              <a:extLst>
                <a:ext uri="{FF2B5EF4-FFF2-40B4-BE49-F238E27FC236}">
                  <a16:creationId xmlns:a16="http://schemas.microsoft.com/office/drawing/2014/main" id="{6E3E5352-7C26-F5B3-AFC2-6E96F8EFE721}"/>
                </a:ext>
              </a:extLst>
            </p:cNvPr>
            <p:cNvGrpSpPr/>
            <p:nvPr/>
          </p:nvGrpSpPr>
          <p:grpSpPr>
            <a:xfrm>
              <a:off x="1977555" y="3892580"/>
              <a:ext cx="400050" cy="215444"/>
              <a:chOff x="3629025" y="990600"/>
              <a:chExt cx="400050" cy="215444"/>
            </a:xfrm>
          </p:grpSpPr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id="{BF4FF1BA-3F55-7B53-5381-3371A3972A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29025" y="1088797"/>
                <a:ext cx="40005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C798C70F-42FE-634E-992F-6045EB15F7C6}"/>
                  </a:ext>
                </a:extLst>
              </p:cNvPr>
              <p:cNvSpPr txBox="1"/>
              <p:nvPr/>
            </p:nvSpPr>
            <p:spPr>
              <a:xfrm>
                <a:off x="3706579" y="990600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800" dirty="0">
                    <a:solidFill>
                      <a:srgbClr val="FF0000"/>
                    </a:solidFill>
                  </a:rPr>
                  <a:t>●</a:t>
                </a:r>
                <a:endParaRPr kumimoji="1" lang="ja-JP" altLang="en-US" sz="8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F5F38BD3-48CB-F4E8-2373-28DF5AD0B49F}"/>
                </a:ext>
              </a:extLst>
            </p:cNvPr>
            <p:cNvSpPr txBox="1"/>
            <p:nvPr/>
          </p:nvSpPr>
          <p:spPr>
            <a:xfrm>
              <a:off x="2391060" y="4287115"/>
              <a:ext cx="1217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 New Roman" pitchFamily="18" charset="0"/>
                  <a:cs typeface="Times New Roman" pitchFamily="18" charset="0"/>
                </a:rPr>
                <a:t>Q4 of serum ferritin</a:t>
              </a:r>
              <a:endParaRPr lang="ja-JP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8FFED14F-2AE0-5CA2-9EC9-3E790EEF357E}"/>
                </a:ext>
              </a:extLst>
            </p:cNvPr>
            <p:cNvGrpSpPr/>
            <p:nvPr/>
          </p:nvGrpSpPr>
          <p:grpSpPr>
            <a:xfrm>
              <a:off x="1990614" y="4325357"/>
              <a:ext cx="400050" cy="215444"/>
              <a:chOff x="2160446" y="672104"/>
              <a:chExt cx="400050" cy="215444"/>
            </a:xfrm>
          </p:grpSpPr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F51DD0AD-E5E9-F563-4414-DBE5A36D7E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60446" y="770301"/>
                <a:ext cx="400050" cy="0"/>
              </a:xfrm>
              <a:prstGeom prst="line">
                <a:avLst/>
              </a:prstGeom>
              <a:ln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0DCCD597-C14B-F8FE-A7E3-4525B716ED6B}"/>
                  </a:ext>
                </a:extLst>
              </p:cNvPr>
              <p:cNvSpPr txBox="1"/>
              <p:nvPr/>
            </p:nvSpPr>
            <p:spPr>
              <a:xfrm>
                <a:off x="2238000" y="672104"/>
                <a:ext cx="28725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800" dirty="0">
                    <a:solidFill>
                      <a:srgbClr val="00B050"/>
                    </a:solidFill>
                  </a:rPr>
                  <a:t>●</a:t>
                </a:r>
                <a:endParaRPr kumimoji="1" lang="ja-JP" altLang="en-US" sz="800" dirty="0">
                  <a:solidFill>
                    <a:srgbClr val="00B050"/>
                  </a:solidFill>
                </a:endParaRPr>
              </a:p>
            </p:txBody>
          </p:sp>
        </p:grp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5A71C5AD-C148-A99F-578E-FA958C1A7560}"/>
                </a:ext>
              </a:extLst>
            </p:cNvPr>
            <p:cNvSpPr txBox="1"/>
            <p:nvPr/>
          </p:nvSpPr>
          <p:spPr>
            <a:xfrm>
              <a:off x="2053497" y="368643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800" dirty="0">
                  <a:solidFill>
                    <a:srgbClr val="2529D1"/>
                  </a:solidFill>
                </a:rPr>
                <a:t>●</a:t>
              </a:r>
              <a:endParaRPr kumimoji="1" lang="ja-JP" altLang="en-US" sz="800" dirty="0">
                <a:solidFill>
                  <a:srgbClr val="2529D1"/>
                </a:solidFill>
              </a:endParaRPr>
            </a:p>
          </p:txBody>
        </p: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6381EC35-D943-04D5-09CB-12246FE6EA3D}"/>
                </a:ext>
              </a:extLst>
            </p:cNvPr>
            <p:cNvCxnSpPr>
              <a:cxnSpLocks/>
            </p:cNvCxnSpPr>
            <p:nvPr/>
          </p:nvCxnSpPr>
          <p:spPr>
            <a:xfrm>
              <a:off x="1994990" y="3786702"/>
              <a:ext cx="400050" cy="0"/>
            </a:xfrm>
            <a:prstGeom prst="line">
              <a:avLst/>
            </a:prstGeom>
            <a:ln>
              <a:solidFill>
                <a:srgbClr val="17239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98854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130</Words>
  <Application>Microsoft Office PowerPoint</Application>
  <PresentationFormat>ワイド画面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山　勝／Nakayama,Masaru</dc:creator>
  <cp:lastModifiedBy>腎臓内科 九州医療</cp:lastModifiedBy>
  <cp:revision>36</cp:revision>
  <dcterms:created xsi:type="dcterms:W3CDTF">2021-05-22T01:32:27Z</dcterms:created>
  <dcterms:modified xsi:type="dcterms:W3CDTF">2023-09-14T03:57:48Z</dcterms:modified>
</cp:coreProperties>
</file>